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BBC85EE-71A7-4183-8D66-B38E95D652A0}" v="4" dt="2021-12-01T16:31:26.93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6" autoAdjust="0"/>
    <p:restoredTop sz="94660"/>
  </p:normalViewPr>
  <p:slideViewPr>
    <p:cSldViewPr snapToGrid="0">
      <p:cViewPr varScale="1">
        <p:scale>
          <a:sx n="79" d="100"/>
          <a:sy n="79" d="100"/>
        </p:scale>
        <p:origin x="9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erbert, Carly" userId="76a06a7c-f64e-4c29-ad97-3b749278fbce" providerId="ADAL" clId="{8BBC85EE-71A7-4183-8D66-B38E95D652A0}"/>
    <pc:docChg chg="addSld modSld sldOrd">
      <pc:chgData name="Herbert, Carly" userId="76a06a7c-f64e-4c29-ad97-3b749278fbce" providerId="ADAL" clId="{8BBC85EE-71A7-4183-8D66-B38E95D652A0}" dt="2021-12-01T16:40:40.345" v="273" actId="1076"/>
      <pc:docMkLst>
        <pc:docMk/>
      </pc:docMkLst>
      <pc:sldChg chg="addSp modSp mod">
        <pc:chgData name="Herbert, Carly" userId="76a06a7c-f64e-4c29-ad97-3b749278fbce" providerId="ADAL" clId="{8BBC85EE-71A7-4183-8D66-B38E95D652A0}" dt="2021-12-01T16:40:40.345" v="273" actId="1076"/>
        <pc:sldMkLst>
          <pc:docMk/>
          <pc:sldMk cId="2320116339" sldId="256"/>
        </pc:sldMkLst>
        <pc:spChg chg="add mod">
          <ac:chgData name="Herbert, Carly" userId="76a06a7c-f64e-4c29-ad97-3b749278fbce" providerId="ADAL" clId="{8BBC85EE-71A7-4183-8D66-B38E95D652A0}" dt="2021-12-01T16:40:15.111" v="270" actId="1076"/>
          <ac:spMkLst>
            <pc:docMk/>
            <pc:sldMk cId="2320116339" sldId="256"/>
            <ac:spMk id="2" creationId="{539864BF-5B5B-4C5D-AEA8-A3A7E674BA62}"/>
          </ac:spMkLst>
        </pc:spChg>
        <pc:picChg chg="mod">
          <ac:chgData name="Herbert, Carly" userId="76a06a7c-f64e-4c29-ad97-3b749278fbce" providerId="ADAL" clId="{8BBC85EE-71A7-4183-8D66-B38E95D652A0}" dt="2021-12-01T16:40:40.345" v="273" actId="1076"/>
          <ac:picMkLst>
            <pc:docMk/>
            <pc:sldMk cId="2320116339" sldId="256"/>
            <ac:picMk id="6" creationId="{65E4CA69-676D-4988-9D78-FAC83511F1DA}"/>
          </ac:picMkLst>
        </pc:picChg>
        <pc:picChg chg="mod">
          <ac:chgData name="Herbert, Carly" userId="76a06a7c-f64e-4c29-ad97-3b749278fbce" providerId="ADAL" clId="{8BBC85EE-71A7-4183-8D66-B38E95D652A0}" dt="2021-12-01T16:40:35.057" v="272" actId="1076"/>
          <ac:picMkLst>
            <pc:docMk/>
            <pc:sldMk cId="2320116339" sldId="256"/>
            <ac:picMk id="7" creationId="{C1D3FA87-08AB-4507-BE0F-FF2B6B6D589A}"/>
          </ac:picMkLst>
        </pc:picChg>
      </pc:sldChg>
      <pc:sldChg chg="addSp delSp modSp new mod ord">
        <pc:chgData name="Herbert, Carly" userId="76a06a7c-f64e-4c29-ad97-3b749278fbce" providerId="ADAL" clId="{8BBC85EE-71A7-4183-8D66-B38E95D652A0}" dt="2021-12-01T16:38:55.820" v="256" actId="1076"/>
        <pc:sldMkLst>
          <pc:docMk/>
          <pc:sldMk cId="3650594971" sldId="257"/>
        </pc:sldMkLst>
        <pc:spChg chg="del">
          <ac:chgData name="Herbert, Carly" userId="76a06a7c-f64e-4c29-ad97-3b749278fbce" providerId="ADAL" clId="{8BBC85EE-71A7-4183-8D66-B38E95D652A0}" dt="2021-12-01T16:21:19.694" v="145" actId="22"/>
          <ac:spMkLst>
            <pc:docMk/>
            <pc:sldMk cId="3650594971" sldId="257"/>
            <ac:spMk id="3" creationId="{4DB8DAF0-F9E8-4CA2-A3BA-47A82B9F5EAF}"/>
          </ac:spMkLst>
        </pc:spChg>
        <pc:spChg chg="add del mod">
          <ac:chgData name="Herbert, Carly" userId="76a06a7c-f64e-4c29-ad97-3b749278fbce" providerId="ADAL" clId="{8BBC85EE-71A7-4183-8D66-B38E95D652A0}" dt="2021-12-01T16:30:12.204" v="206"/>
          <ac:spMkLst>
            <pc:docMk/>
            <pc:sldMk cId="3650594971" sldId="257"/>
            <ac:spMk id="12" creationId="{76F29E06-E9FB-4C5E-82D6-04BDCE123716}"/>
          </ac:spMkLst>
        </pc:spChg>
        <pc:spChg chg="add mod">
          <ac:chgData name="Herbert, Carly" userId="76a06a7c-f64e-4c29-ad97-3b749278fbce" providerId="ADAL" clId="{8BBC85EE-71A7-4183-8D66-B38E95D652A0}" dt="2021-12-01T16:38:55.820" v="256" actId="1076"/>
          <ac:spMkLst>
            <pc:docMk/>
            <pc:sldMk cId="3650594971" sldId="257"/>
            <ac:spMk id="14" creationId="{4964DE33-0D52-4146-BAE3-1348815AC95F}"/>
          </ac:spMkLst>
        </pc:spChg>
        <pc:picChg chg="add mod modCrop">
          <ac:chgData name="Herbert, Carly" userId="76a06a7c-f64e-4c29-ad97-3b749278fbce" providerId="ADAL" clId="{8BBC85EE-71A7-4183-8D66-B38E95D652A0}" dt="2021-12-01T16:38:22.842" v="250" actId="14100"/>
          <ac:picMkLst>
            <pc:docMk/>
            <pc:sldMk cId="3650594971" sldId="257"/>
            <ac:picMk id="5" creationId="{4CFB65AC-F005-4715-A414-EBC1A4890351}"/>
          </ac:picMkLst>
        </pc:picChg>
        <pc:picChg chg="add mod modCrop">
          <ac:chgData name="Herbert, Carly" userId="76a06a7c-f64e-4c29-ad97-3b749278fbce" providerId="ADAL" clId="{8BBC85EE-71A7-4183-8D66-B38E95D652A0}" dt="2021-12-01T16:38:28.085" v="251" actId="14100"/>
          <ac:picMkLst>
            <pc:docMk/>
            <pc:sldMk cId="3650594971" sldId="257"/>
            <ac:picMk id="7" creationId="{15F235AF-FE2E-4C6B-B046-75DA87ECD91D}"/>
          </ac:picMkLst>
        </pc:picChg>
        <pc:picChg chg="add mod modCrop">
          <ac:chgData name="Herbert, Carly" userId="76a06a7c-f64e-4c29-ad97-3b749278fbce" providerId="ADAL" clId="{8BBC85EE-71A7-4183-8D66-B38E95D652A0}" dt="2021-12-01T16:38:32.945" v="252" actId="14100"/>
          <ac:picMkLst>
            <pc:docMk/>
            <pc:sldMk cId="3650594971" sldId="257"/>
            <ac:picMk id="9" creationId="{F3CDA8D5-008C-438D-A31A-DD246D59DB8B}"/>
          </ac:picMkLst>
        </pc:picChg>
        <pc:picChg chg="add mod ord">
          <ac:chgData name="Herbert, Carly" userId="76a06a7c-f64e-4c29-ad97-3b749278fbce" providerId="ADAL" clId="{8BBC85EE-71A7-4183-8D66-B38E95D652A0}" dt="2021-12-01T16:38:40.726" v="253" actId="14100"/>
          <ac:picMkLst>
            <pc:docMk/>
            <pc:sldMk cId="3650594971" sldId="257"/>
            <ac:picMk id="11" creationId="{AD1A750B-F822-49A9-831B-449390B99679}"/>
          </ac:picMkLst>
        </pc:picChg>
      </pc:sldChg>
      <pc:sldChg chg="addSp delSp modSp new mod">
        <pc:chgData name="Herbert, Carly" userId="76a06a7c-f64e-4c29-ad97-3b749278fbce" providerId="ADAL" clId="{8BBC85EE-71A7-4183-8D66-B38E95D652A0}" dt="2021-12-01T16:39:21.201" v="262" actId="14100"/>
        <pc:sldMkLst>
          <pc:docMk/>
          <pc:sldMk cId="1986501100" sldId="258"/>
        </pc:sldMkLst>
        <pc:spChg chg="del">
          <ac:chgData name="Herbert, Carly" userId="76a06a7c-f64e-4c29-ad97-3b749278fbce" providerId="ADAL" clId="{8BBC85EE-71A7-4183-8D66-B38E95D652A0}" dt="2021-12-01T16:24:35.340" v="168" actId="22"/>
          <ac:spMkLst>
            <pc:docMk/>
            <pc:sldMk cId="1986501100" sldId="258"/>
            <ac:spMk id="3" creationId="{03630818-4F40-4D6D-A21C-D2596BCBE687}"/>
          </ac:spMkLst>
        </pc:spChg>
        <pc:spChg chg="add mod">
          <ac:chgData name="Herbert, Carly" userId="76a06a7c-f64e-4c29-ad97-3b749278fbce" providerId="ADAL" clId="{8BBC85EE-71A7-4183-8D66-B38E95D652A0}" dt="2021-12-01T16:39:07.275" v="258" actId="1076"/>
          <ac:spMkLst>
            <pc:docMk/>
            <pc:sldMk cId="1986501100" sldId="258"/>
            <ac:spMk id="12" creationId="{0C3097CD-76A4-48F3-A02A-C7CC88768196}"/>
          </ac:spMkLst>
        </pc:spChg>
        <pc:picChg chg="add mod">
          <ac:chgData name="Herbert, Carly" userId="76a06a7c-f64e-4c29-ad97-3b749278fbce" providerId="ADAL" clId="{8BBC85EE-71A7-4183-8D66-B38E95D652A0}" dt="2021-12-01T16:39:11.258" v="259" actId="14100"/>
          <ac:picMkLst>
            <pc:docMk/>
            <pc:sldMk cId="1986501100" sldId="258"/>
            <ac:picMk id="5" creationId="{8892838D-EBA1-4F98-86E4-C9E9B96651D0}"/>
          </ac:picMkLst>
        </pc:picChg>
        <pc:picChg chg="add mod ord">
          <ac:chgData name="Herbert, Carly" userId="76a06a7c-f64e-4c29-ad97-3b749278fbce" providerId="ADAL" clId="{8BBC85EE-71A7-4183-8D66-B38E95D652A0}" dt="2021-12-01T16:39:14.773" v="260" actId="14100"/>
          <ac:picMkLst>
            <pc:docMk/>
            <pc:sldMk cId="1986501100" sldId="258"/>
            <ac:picMk id="7" creationId="{2C17BB19-64BA-4354-9DE6-72C2213DC6ED}"/>
          </ac:picMkLst>
        </pc:picChg>
        <pc:picChg chg="add mod">
          <ac:chgData name="Herbert, Carly" userId="76a06a7c-f64e-4c29-ad97-3b749278fbce" providerId="ADAL" clId="{8BBC85EE-71A7-4183-8D66-B38E95D652A0}" dt="2021-12-01T16:39:17.739" v="261" actId="14100"/>
          <ac:picMkLst>
            <pc:docMk/>
            <pc:sldMk cId="1986501100" sldId="258"/>
            <ac:picMk id="9" creationId="{D552D93B-F7C6-4BD0-8B43-C9E531C175C5}"/>
          </ac:picMkLst>
        </pc:picChg>
        <pc:picChg chg="add mod">
          <ac:chgData name="Herbert, Carly" userId="76a06a7c-f64e-4c29-ad97-3b749278fbce" providerId="ADAL" clId="{8BBC85EE-71A7-4183-8D66-B38E95D652A0}" dt="2021-12-01T16:39:21.201" v="262" actId="14100"/>
          <ac:picMkLst>
            <pc:docMk/>
            <pc:sldMk cId="1986501100" sldId="258"/>
            <ac:picMk id="11" creationId="{3F85F2A4-A336-40EB-AD8B-E58FC3520CCE}"/>
          </ac:picMkLst>
        </pc:picChg>
      </pc:sldChg>
      <pc:sldChg chg="addSp delSp modSp new mod">
        <pc:chgData name="Herbert, Carly" userId="76a06a7c-f64e-4c29-ad97-3b749278fbce" providerId="ADAL" clId="{8BBC85EE-71A7-4183-8D66-B38E95D652A0}" dt="2021-12-01T16:39:57.831" v="268" actId="14100"/>
        <pc:sldMkLst>
          <pc:docMk/>
          <pc:sldMk cId="2818070343" sldId="259"/>
        </pc:sldMkLst>
        <pc:spChg chg="del">
          <ac:chgData name="Herbert, Carly" userId="76a06a7c-f64e-4c29-ad97-3b749278fbce" providerId="ADAL" clId="{8BBC85EE-71A7-4183-8D66-B38E95D652A0}" dt="2021-12-01T16:27:51.170" v="181" actId="22"/>
          <ac:spMkLst>
            <pc:docMk/>
            <pc:sldMk cId="2818070343" sldId="259"/>
            <ac:spMk id="3" creationId="{B83F2327-626C-4CC9-A3F0-027EFA30B51C}"/>
          </ac:spMkLst>
        </pc:spChg>
        <pc:spChg chg="add mod">
          <ac:chgData name="Herbert, Carly" userId="76a06a7c-f64e-4c29-ad97-3b749278fbce" providerId="ADAL" clId="{8BBC85EE-71A7-4183-8D66-B38E95D652A0}" dt="2021-12-01T16:39:32.589" v="264" actId="1076"/>
          <ac:spMkLst>
            <pc:docMk/>
            <pc:sldMk cId="2818070343" sldId="259"/>
            <ac:spMk id="12" creationId="{FB90A526-D0BA-445E-8A6D-B00EAB4E0436}"/>
          </ac:spMkLst>
        </pc:spChg>
        <pc:picChg chg="add mod modCrop">
          <ac:chgData name="Herbert, Carly" userId="76a06a7c-f64e-4c29-ad97-3b749278fbce" providerId="ADAL" clId="{8BBC85EE-71A7-4183-8D66-B38E95D652A0}" dt="2021-12-01T16:39:35.951" v="265" actId="14100"/>
          <ac:picMkLst>
            <pc:docMk/>
            <pc:sldMk cId="2818070343" sldId="259"/>
            <ac:picMk id="5" creationId="{51F139B8-D9E9-4F7A-BC37-F8538D583AC0}"/>
          </ac:picMkLst>
        </pc:picChg>
        <pc:picChg chg="add mod modCrop">
          <ac:chgData name="Herbert, Carly" userId="76a06a7c-f64e-4c29-ad97-3b749278fbce" providerId="ADAL" clId="{8BBC85EE-71A7-4183-8D66-B38E95D652A0}" dt="2021-12-01T16:39:47.416" v="266" actId="14100"/>
          <ac:picMkLst>
            <pc:docMk/>
            <pc:sldMk cId="2818070343" sldId="259"/>
            <ac:picMk id="7" creationId="{AE1E56D6-45C0-4BB8-BBAB-130C98ECDD95}"/>
          </ac:picMkLst>
        </pc:picChg>
        <pc:picChg chg="add mod modCrop">
          <ac:chgData name="Herbert, Carly" userId="76a06a7c-f64e-4c29-ad97-3b749278fbce" providerId="ADAL" clId="{8BBC85EE-71A7-4183-8D66-B38E95D652A0}" dt="2021-12-01T16:39:52.566" v="267" actId="14100"/>
          <ac:picMkLst>
            <pc:docMk/>
            <pc:sldMk cId="2818070343" sldId="259"/>
            <ac:picMk id="9" creationId="{9C2C2532-35E6-415B-BD07-E588FD7D1984}"/>
          </ac:picMkLst>
        </pc:picChg>
        <pc:picChg chg="add mod ord modCrop">
          <ac:chgData name="Herbert, Carly" userId="76a06a7c-f64e-4c29-ad97-3b749278fbce" providerId="ADAL" clId="{8BBC85EE-71A7-4183-8D66-B38E95D652A0}" dt="2021-12-01T16:39:57.831" v="268" actId="14100"/>
          <ac:picMkLst>
            <pc:docMk/>
            <pc:sldMk cId="2818070343" sldId="259"/>
            <ac:picMk id="11" creationId="{7062FDE8-645A-4DA6-9422-A8D17D26016A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C7672D-90F7-49E0-9CC5-6E601CC952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823A51D-467F-4485-ADE5-F12C06E5F2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621BD3-3D8C-441D-98F9-A8B6845E26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0A60ED-5D9F-4FAF-97EE-F34A2A4E7883}" type="datetimeFigureOut">
              <a:rPr lang="en-US" smtClean="0"/>
              <a:t>12/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924D7E-E82E-439D-88C6-31A6A844FE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C30FBA-E064-4C8C-B89C-F7F991C18B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3D157B-4D19-4598-AF29-3E89964743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153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2BD0F5-28C0-442A-8D3F-19771758DA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81393A-6F8A-4CCB-BB13-41E59B415C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7F86A0-C3F7-49C5-B08F-D27A2DE46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0A60ED-5D9F-4FAF-97EE-F34A2A4E7883}" type="datetimeFigureOut">
              <a:rPr lang="en-US" smtClean="0"/>
              <a:t>12/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1CA113-5884-4C7F-98E1-6DB774DB2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9058D2-346C-4959-99A9-2B2A3945B6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3D157B-4D19-4598-AF29-3E89964743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879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3B2B7C4-BA8C-4509-B5A6-838EB9DAAA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C81AE5F-539A-4D9E-8483-41CEA90260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8586D6-52D9-4312-BF37-6E96B1BCBE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0A60ED-5D9F-4FAF-97EE-F34A2A4E7883}" type="datetimeFigureOut">
              <a:rPr lang="en-US" smtClean="0"/>
              <a:t>12/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3A30A6-19E8-4D35-A464-2A2134F522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B9548D-755B-430A-9F6F-8581677FBF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3D157B-4D19-4598-AF29-3E89964743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15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A3CA19-7DF7-4935-AE9D-4A9C41E6FE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EDA55E-D25D-4966-A0DD-359CEFAE5B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EA149A-185A-43B3-83CF-746C079A7E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0A60ED-5D9F-4FAF-97EE-F34A2A4E7883}" type="datetimeFigureOut">
              <a:rPr lang="en-US" smtClean="0"/>
              <a:t>12/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1677E5-EF25-41EF-92BA-2E26FDC03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87FABF-E2B1-4753-9734-C8BD55F9AE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3D157B-4D19-4598-AF29-3E89964743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905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579DB7-C57E-4A79-B94C-C1669EEF5A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B9CE33-E512-4CEF-AB57-59FC204E66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11A40E-4EFB-4511-A604-6A1E2197B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0A60ED-5D9F-4FAF-97EE-F34A2A4E7883}" type="datetimeFigureOut">
              <a:rPr lang="en-US" smtClean="0"/>
              <a:t>12/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BB6651-41ED-4D42-892D-A4246BA67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64C109-1D24-4205-8E9B-F658529587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3D157B-4D19-4598-AF29-3E89964743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7484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90A720-71C8-4E33-AF3D-720F0C1130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48551E-BB98-4037-833A-D2505611A8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3C82DF-FF5C-4512-8D89-43D94FCFE3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0A3C7A-4583-4E79-94BE-2A293FBA5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0A60ED-5D9F-4FAF-97EE-F34A2A4E7883}" type="datetimeFigureOut">
              <a:rPr lang="en-US" smtClean="0"/>
              <a:t>12/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113F1A-F0B0-4C63-89F8-FF941A6405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DFA807-29BA-4C4C-9211-C624CC1F55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3D157B-4D19-4598-AF29-3E89964743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978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389F43-F80F-468C-8D81-B70911D117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D85027-D20B-4F8F-9550-862FEDBB2D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6992AE-BA7C-4BB6-BD62-57E6A6C458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C4001F-7F09-4F16-B369-4BA3520E6C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B0FF081-36D1-42E9-B8A7-C272DC6430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E0526AB-73A6-4788-A01B-1462CA6BAD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0A60ED-5D9F-4FAF-97EE-F34A2A4E7883}" type="datetimeFigureOut">
              <a:rPr lang="en-US" smtClean="0"/>
              <a:t>12/1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B255778-21EC-46F8-889C-851FFE724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A59091-2A1D-4057-A57D-2837B8F60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3D157B-4D19-4598-AF29-3E89964743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106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C70F98-69D9-48D9-A1FD-3F7DFE06DB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2DE674-00AC-4739-AC5C-710E0CB3B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0A60ED-5D9F-4FAF-97EE-F34A2A4E7883}" type="datetimeFigureOut">
              <a:rPr lang="en-US" smtClean="0"/>
              <a:t>12/1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955DBD9-832E-496A-A5DB-10A8C653A4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49E6CBE-0FE0-4995-9567-439E808ABA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3D157B-4D19-4598-AF29-3E89964743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295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019AF89-A735-4707-AE54-BE2D39D33C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0A60ED-5D9F-4FAF-97EE-F34A2A4E7883}" type="datetimeFigureOut">
              <a:rPr lang="en-US" smtClean="0"/>
              <a:t>12/1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540EB6-7A2A-461F-9628-0672C722D6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7676E6-4638-414C-9A03-D8FD20912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3D157B-4D19-4598-AF29-3E89964743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700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D69EAB-7AEA-44BE-B973-635433F151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E7B08B-6724-459C-89EC-3981C76563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F3818D-D8AB-4261-94DB-B1C50E9B3A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8F6934-98FF-4EDE-9123-98788E4C2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0A60ED-5D9F-4FAF-97EE-F34A2A4E7883}" type="datetimeFigureOut">
              <a:rPr lang="en-US" smtClean="0"/>
              <a:t>12/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D6DA8B-4A81-4E0F-8267-DBEC8E15A2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869EF5-875C-44E4-ACCE-CA1A6178E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3D157B-4D19-4598-AF29-3E89964743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898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5CB6C-B70A-4720-ADB1-A19997A7B2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EC33437-9894-4350-9D7C-0DBE92A4BF2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269CFBD-68F0-4EFC-A47A-F33A9BB51C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3474C3-DDCD-4D17-A811-04BFFE55C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0A60ED-5D9F-4FAF-97EE-F34A2A4E7883}" type="datetimeFigureOut">
              <a:rPr lang="en-US" smtClean="0"/>
              <a:t>12/1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338B3C-320D-4A52-8DBB-0F3231B7A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1196B6-EE99-4B92-8E23-D934144DB8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3D157B-4D19-4598-AF29-3E89964743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4562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84F4E8-E425-480C-99B5-FD6EAB08AB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562586-BB30-4311-9467-279E52CBB3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0462F7-758A-470B-9D0A-ED899BF903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0A60ED-5D9F-4FAF-97EE-F34A2A4E7883}" type="datetimeFigureOut">
              <a:rPr lang="en-US" smtClean="0"/>
              <a:t>12/1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5C4B8E-8BD8-4570-B1A9-0DAD207469D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C4DD1F-9D1B-4E96-8C5E-41D99C34ED0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3D157B-4D19-4598-AF29-3E89964743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257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93405A-741D-4EF1-97D8-80EE91E328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11" name="Content Placeholder 10">
            <a:extLst>
              <a:ext uri="{FF2B5EF4-FFF2-40B4-BE49-F238E27FC236}">
                <a16:creationId xmlns:a16="http://schemas.microsoft.com/office/drawing/2014/main" id="{AD1A750B-F822-49A9-831B-449390B9967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9098143" y="1"/>
            <a:ext cx="2964882" cy="5058382"/>
          </a:xfr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CFB65AC-F005-4715-A414-EBC1A489035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93" r="1422"/>
          <a:stretch/>
        </p:blipFill>
        <p:spPr>
          <a:xfrm>
            <a:off x="53676" y="-1"/>
            <a:ext cx="2859450" cy="540857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5F235AF-FE2E-4C6B-B046-75DA87ECD91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063" t="3577" r="2200"/>
          <a:stretch/>
        </p:blipFill>
        <p:spPr>
          <a:xfrm>
            <a:off x="2885600" y="96665"/>
            <a:ext cx="3042348" cy="392085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3CDA8D5-008C-438D-A31A-DD246D59DB8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6395"/>
          <a:stretch/>
        </p:blipFill>
        <p:spPr>
          <a:xfrm>
            <a:off x="5927948" y="0"/>
            <a:ext cx="3170195" cy="5408577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964DE33-0D52-4146-BAE3-1348815AC95F}"/>
              </a:ext>
            </a:extLst>
          </p:cNvPr>
          <p:cNvSpPr txBox="1"/>
          <p:nvPr/>
        </p:nvSpPr>
        <p:spPr>
          <a:xfrm>
            <a:off x="2807982" y="6405267"/>
            <a:ext cx="824919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s: Screenshots of Ag-RDT Instructions through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DataHelp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pp</a:t>
            </a:r>
          </a:p>
        </p:txBody>
      </p:sp>
    </p:spTree>
    <p:extLst>
      <p:ext uri="{BB962C8B-B14F-4D97-AF65-F5344CB8AC3E}">
        <p14:creationId xmlns:p14="http://schemas.microsoft.com/office/powerpoint/2010/main" val="36505949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ABDD6F-82A7-4798-93BE-998A9BCE50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2C17BB19-64BA-4354-9DE6-72C2213DC6E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147333" y="0"/>
            <a:ext cx="2958335" cy="5437762"/>
          </a:xfr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892838D-EBA1-4F98-86E4-C9E9B96651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0"/>
            <a:ext cx="3147333" cy="543776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552D93B-F7C6-4BD0-8B43-C9E531C175C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05668" y="38102"/>
            <a:ext cx="3093988" cy="539965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F85F2A4-A336-40EB-AD8B-E58FC3520CC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132589" y="38103"/>
            <a:ext cx="3025402" cy="4708995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0C3097CD-76A4-48F3-A02A-C7CC88768196}"/>
              </a:ext>
            </a:extLst>
          </p:cNvPr>
          <p:cNvSpPr txBox="1"/>
          <p:nvPr/>
        </p:nvSpPr>
        <p:spPr>
          <a:xfrm>
            <a:off x="2781974" y="6492875"/>
            <a:ext cx="824919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s: Screenshots of Ag-RDT Instructions through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DataHelp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pp</a:t>
            </a:r>
          </a:p>
        </p:txBody>
      </p:sp>
    </p:spTree>
    <p:extLst>
      <p:ext uri="{BB962C8B-B14F-4D97-AF65-F5344CB8AC3E}">
        <p14:creationId xmlns:p14="http://schemas.microsoft.com/office/powerpoint/2010/main" val="19865011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FF15D3-A59D-488C-9034-4304DFAFC9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11" name="Content Placeholder 10">
            <a:extLst>
              <a:ext uri="{FF2B5EF4-FFF2-40B4-BE49-F238E27FC236}">
                <a16:creationId xmlns:a16="http://schemas.microsoft.com/office/drawing/2014/main" id="{7062FDE8-645A-4DA6-9422-A8D17D26016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204"/>
          <a:stretch/>
        </p:blipFill>
        <p:spPr>
          <a:xfrm>
            <a:off x="9117018" y="0"/>
            <a:ext cx="2900487" cy="5291846"/>
          </a:xfr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1F139B8-D9E9-4F7A-BC37-F8538D583AC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402" r="-1"/>
          <a:stretch/>
        </p:blipFill>
        <p:spPr>
          <a:xfrm>
            <a:off x="0" y="0"/>
            <a:ext cx="3012226" cy="567122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E1E56D6-45C0-4BB8-BBAB-130C98ECDD9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584" r="1"/>
          <a:stretch/>
        </p:blipFill>
        <p:spPr>
          <a:xfrm>
            <a:off x="2958262" y="-1"/>
            <a:ext cx="3074982" cy="550585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C2C2532-35E6-415B-BD07-E588FD7D198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412" r="-555"/>
          <a:stretch/>
        </p:blipFill>
        <p:spPr>
          <a:xfrm>
            <a:off x="6033244" y="-1"/>
            <a:ext cx="3074982" cy="529184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B90A526-D0BA-445E-8A6D-B00EAB4E0436}"/>
              </a:ext>
            </a:extLst>
          </p:cNvPr>
          <p:cNvSpPr txBox="1"/>
          <p:nvPr/>
        </p:nvSpPr>
        <p:spPr>
          <a:xfrm>
            <a:off x="2958262" y="6492875"/>
            <a:ext cx="824919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s: Screenshots of Ag-RDT Instructions through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DataHelp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pp</a:t>
            </a:r>
          </a:p>
        </p:txBody>
      </p:sp>
    </p:spTree>
    <p:extLst>
      <p:ext uri="{BB962C8B-B14F-4D97-AF65-F5344CB8AC3E}">
        <p14:creationId xmlns:p14="http://schemas.microsoft.com/office/powerpoint/2010/main" val="28180703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BC6462C-0ECC-47FF-8A55-D9457BE65E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3995797" cy="580861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5E4CA69-676D-4988-9D78-FAC83511F1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81978" y="22885"/>
            <a:ext cx="3964310" cy="580861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1D3FA87-08AB-4507-BE0F-FF2B6B6D589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733" r="15261"/>
          <a:stretch/>
        </p:blipFill>
        <p:spPr>
          <a:xfrm>
            <a:off x="8132469" y="22885"/>
            <a:ext cx="3697987" cy="576284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39864BF-5B5B-4C5D-AEA8-A3A7E674BA62}"/>
              </a:ext>
            </a:extLst>
          </p:cNvPr>
          <p:cNvSpPr txBox="1"/>
          <p:nvPr/>
        </p:nvSpPr>
        <p:spPr>
          <a:xfrm>
            <a:off x="2960936" y="6550223"/>
            <a:ext cx="84436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s: Screenshots of Test Interpretation through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DataHelp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pp</a:t>
            </a:r>
          </a:p>
        </p:txBody>
      </p:sp>
    </p:spTree>
    <p:extLst>
      <p:ext uri="{BB962C8B-B14F-4D97-AF65-F5344CB8AC3E}">
        <p14:creationId xmlns:p14="http://schemas.microsoft.com/office/powerpoint/2010/main" val="2320116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5</TotalTime>
  <Words>40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rbert, Carly</dc:creator>
  <cp:lastModifiedBy>Herbert, Carly</cp:lastModifiedBy>
  <cp:revision>1</cp:revision>
  <dcterms:created xsi:type="dcterms:W3CDTF">2021-11-30T17:09:03Z</dcterms:created>
  <dcterms:modified xsi:type="dcterms:W3CDTF">2021-12-01T16:40:45Z</dcterms:modified>
</cp:coreProperties>
</file>